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72" r:id="rId2"/>
    <p:sldId id="266" r:id="rId3"/>
    <p:sldId id="261" r:id="rId4"/>
    <p:sldId id="264" r:id="rId5"/>
    <p:sldId id="258" r:id="rId6"/>
    <p:sldId id="267" r:id="rId7"/>
    <p:sldId id="268" r:id="rId8"/>
    <p:sldId id="270" r:id="rId9"/>
    <p:sldId id="271" r:id="rId10"/>
    <p:sldId id="259" r:id="rId11"/>
    <p:sldId id="269" r:id="rId12"/>
    <p:sldId id="273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5271"/>
  </p:normalViewPr>
  <p:slideViewPr>
    <p:cSldViewPr snapToGrid="0" snapToObjects="1">
      <p:cViewPr varScale="1">
        <p:scale>
          <a:sx n="122" d="100"/>
          <a:sy n="122" d="100"/>
        </p:scale>
        <p:origin x="114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5955C85-2BF4-4E48-BDB7-29F99AA52C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D3AFC836-A198-124F-9E78-CFFA7BA9AC7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194071F-E4CA-EB4D-8CAB-305F9521FF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0F11D63F-15BC-8F4C-9F38-D77F3921A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4B7E0BA-D325-3743-AC46-078A319AD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72623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01F27A60-BBE5-BD45-9B67-EDF7890BC3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BD9DDBE4-2C0E-DE4F-96F3-1116840594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A2F7E2F-45C5-4444-A9BE-CC41E714D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219DD1CB-EC21-5D4A-9498-0354F969E6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F671286-46D3-224C-BCC3-45B2FE4CF5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60818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B46A4ED5-A96E-8347-A515-E89E5C352D7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FC1F08BA-265D-1945-B3E8-C5AEF35F2CF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0C3949C9-C19E-CB4E-9D84-16F9D2E8AA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B6BB462-168E-DE47-B224-76FB82B7A9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39976941-E036-B74C-B174-24E73601A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4102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ED50A27-FBD8-2145-824A-D35B1466BA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BECD2181-AC2F-F848-A7EE-E0BE3896064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355A7416-07BA-D748-A293-7B91DCD902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1E3EE21-86EE-4448-8CE4-3CE40DC28E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9FBC2005-AEF3-5C4E-B8BC-84291A20E3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96469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FE77278-2D8B-334B-B18D-F730F08AD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0D0E793-4DAD-8E4E-8528-829AA46771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8B1ADA5E-39D4-754C-9399-7F1B3CB78C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84A859C7-8304-BE4A-98F9-23DC02E709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1E6A3CA6-7C07-8548-B491-E7EFF23F49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06186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9EBF94C-83EB-964C-9497-17EAB80B5E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E5DA6994-8267-A745-873F-20CC5A7CA9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801CF1EC-D89F-214A-990F-45A8087C4C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4B5BF63F-FFDD-A148-9904-ABB785A39A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51963E97-0CE1-BD49-AF89-24D2C85748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2AE8519-8483-4D40-BF6C-1C475F8FD6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613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01868FE-16E0-7142-AF3C-A6BCA1B1D7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BCC84B42-BA34-E54D-8413-2B34286DFE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08EAE6D3-D2E4-CB44-B3AC-58869F44F22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90239F36-8A21-804A-AC70-C3F4EA2FBC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242A5F52-2BEE-454B-8CEF-3CD8AF709A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8178A19E-C768-E146-BC56-5200DCDE7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19DC1AC3-80F3-5B46-A65B-FCD150D2EE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857418BB-2110-E04C-A1E3-F7347750B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2394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9205EC23-42D3-214C-8962-8A7A38E1A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A1D4F15D-7108-BB48-B014-2282B1D27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52D08916-5E00-2A40-AE2A-5547D5BFC6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553F57F8-330B-6A40-9469-315525591C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3714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42C5FF88-1298-8240-8192-78DB09ED1C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AF09E1F3-6A77-6441-B26E-8DF35CCEE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4C5F5E9D-EE1C-F240-BE4E-EBBF34CC9E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56225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B994E08-69B2-7941-A80B-7D96FAD8C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AFF8594F-2A16-0541-88EF-A9AA1EA3E09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21374AAA-0674-3044-B727-F45D7630F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1AD2AEF6-B81F-DA4B-B407-DFE97AE20B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48AAA702-FE58-2D4C-A02E-18F8787F25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0590175E-EE08-4849-B3C9-E439B908C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0303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A8F41F2-ADDF-6740-8E76-0E497D63B6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AD911D70-4A28-6547-B350-E5877A29C42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03C762D9-EC39-A148-8345-6E71D1789B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5150CD29-9B76-854C-BA1A-3B2AE0E4E9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63252BA1-532A-2A49-9485-0E510061D4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DC207C33-DD86-7C49-8312-E338050D89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2378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0A09D31D-0067-8147-8796-719F96F2A6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454C7804-996C-0A4C-ACA5-490963889D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F8A8B3B-77EE-5E4F-A2ED-30606B3FCC2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3658B-3F27-9043-833D-63FDFA250FE9}" type="datetimeFigureOut">
              <a:rPr lang="en-GB" smtClean="0"/>
              <a:t>15/07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B33F2B2-22C2-CD48-B8E6-F7390FE3A6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D604559E-7114-104B-A56B-9ECC13F985B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E8449-CF00-6D4C-AE06-EC1AF2AF1CE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3916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ctangle 5">
            <a:extLst>
              <a:ext uri="{FF2B5EF4-FFF2-40B4-BE49-F238E27FC236}">
                <a16:creationId xmlns="" xmlns:a16="http://schemas.microsoft.com/office/drawing/2014/main" id="{BFE35E65-CE25-4686-BE87-A7FFDE06BE37}"/>
              </a:ext>
            </a:extLst>
          </p:cNvPr>
          <p:cNvSpPr>
            <a:spLocks noGrp="1" noChangeArrowheads="1"/>
          </p:cNvSpPr>
          <p:nvPr>
            <p:ph idx="1"/>
          </p:nvPr>
        </p:nvSpPr>
        <p:spPr bwMode="auto">
          <a:xfrm>
            <a:off x="686179" y="577148"/>
            <a:ext cx="10515600" cy="73866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spAutoFit/>
          </a:bodyPr>
          <a:lstStyle/>
          <a:p>
            <a:pPr marL="0" lvl="0" indent="0" eaLnBrk="0" fontAlgn="base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</a:pPr>
            <a:r>
              <a:rPr lang="en-GB" sz="1400" b="1" u="sng" dirty="0"/>
              <a:t>Supplementary Figures </a:t>
            </a:r>
            <a:r>
              <a:rPr lang="en-GB" sz="1400" b="1" u="sng" dirty="0" smtClean="0"/>
              <a:t>1-10: </a:t>
            </a:r>
            <a:r>
              <a:rPr lang="en-GB" altLang="en-US" sz="1400" dirty="0" smtClean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</a:t>
            </a:r>
            <a:r>
              <a:rPr kumimoji="0" lang="en-GB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alysis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using the ROC plotter tool</a:t>
            </a:r>
            <a:r>
              <a:rPr lang="en-GB" altLang="en-US" sz="1400" baseline="30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o investigate CPT-1A as a biomarker of sensitivity or resistance to endocrine therapy, HER2-directed therapy or chemotherapy in breast cancers. Molecular subgroups were assessed both in terms of complete pathological response </a:t>
            </a:r>
            <a:r>
              <a:rPr kumimoji="0" lang="en-GB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CPR) and </a:t>
            </a:r>
            <a:r>
              <a:rPr kumimoji="0" lang="en-GB" altLang="en-US" sz="14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lapse-free </a:t>
            </a:r>
            <a:r>
              <a:rPr kumimoji="0" lang="en-GB" altLang="en-US" sz="14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urvival (RFS). </a:t>
            </a:r>
            <a:endParaRPr kumimoji="0" lang="en-GB" altLang="en-US" sz="14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2107878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3C12860-49F0-0344-8E06-DCAE89B25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8262" y="263525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9: </a:t>
            </a:r>
            <a:r>
              <a:rPr lang="en-US" sz="1400" b="1" dirty="0"/>
              <a:t>TNBC </a:t>
            </a:r>
            <a:r>
              <a:rPr lang="en-US" sz="1400" b="1" dirty="0" smtClean="0"/>
              <a:t>5yrs RFS -  </a:t>
            </a:r>
            <a:r>
              <a:rPr lang="en-US" sz="1400" b="1" dirty="0"/>
              <a:t>Chemotherapy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5C3C382B-182F-134A-AF21-4F0F428256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556" y="1460097"/>
            <a:ext cx="5797252" cy="44561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9215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3C12860-49F0-0344-8E06-DCAE89B259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95738" y="154110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10: </a:t>
            </a:r>
            <a:r>
              <a:rPr lang="en-US" sz="1400" b="1" dirty="0"/>
              <a:t>TNBC - CPR Chemotherapy 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57753C6C-16E2-BB44-AC1D-57E646F87F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09"/>
          <a:stretch/>
        </p:blipFill>
        <p:spPr>
          <a:xfrm>
            <a:off x="382954" y="1402929"/>
            <a:ext cx="5469009" cy="43413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04164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3C12860-49F0-0344-8E06-DCAE89B25996}"/>
              </a:ext>
            </a:extLst>
          </p:cNvPr>
          <p:cNvSpPr txBox="1">
            <a:spLocks/>
          </p:cNvSpPr>
          <p:nvPr/>
        </p:nvSpPr>
        <p:spPr>
          <a:xfrm>
            <a:off x="320431" y="365125"/>
            <a:ext cx="11033369" cy="1325563"/>
          </a:xfrm>
          <a:prstGeom prst="rect">
            <a:avLst/>
          </a:prstGeom>
        </p:spPr>
        <p:txBody>
          <a:bodyPr/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/>
              <a:t>Supplementary Figure 11: </a:t>
            </a:r>
            <a:r>
              <a:rPr lang="en-GB" sz="1600" b="1" dirty="0" smtClean="0"/>
              <a:t>Genomic </a:t>
            </a:r>
            <a:r>
              <a:rPr lang="en-GB" sz="1600" b="1" dirty="0"/>
              <a:t>alterations of the components of the carnitine shuttle in breast carcinomas from the TCGA and METABRIC cohorts. </a:t>
            </a:r>
            <a:r>
              <a:rPr lang="en-GB" sz="1600" b="1" dirty="0" smtClean="0"/>
              <a:t> Data and graph obtained from </a:t>
            </a:r>
            <a:r>
              <a:rPr lang="en-GB" sz="1600" b="1" dirty="0" err="1" smtClean="0"/>
              <a:t>cBioportal</a:t>
            </a:r>
            <a:r>
              <a:rPr lang="en-GB" sz="1600" b="1" smtClean="0"/>
              <a:t>.</a:t>
            </a:r>
            <a:endParaRPr lang="en-US" sz="1600" b="1" dirty="0"/>
          </a:p>
        </p:txBody>
      </p:sp>
      <p:pic>
        <p:nvPicPr>
          <p:cNvPr id="3" name="Picture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646" y="1253196"/>
            <a:ext cx="11033370" cy="3553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49114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="" xmlns:a16="http://schemas.microsoft.com/office/drawing/2014/main" id="{53163487-32A1-B143-8643-9018B140AE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0877" y="201002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1: Luminal A </a:t>
            </a:r>
            <a:r>
              <a:rPr lang="en-US" sz="1400" b="1" dirty="0" smtClean="0"/>
              <a:t>5yrs </a:t>
            </a:r>
            <a:r>
              <a:rPr lang="en-US" sz="1400" b="1" dirty="0"/>
              <a:t>Relapse Free Survival (RFS) - Endocrine treatment (ET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368D73A0-2FB1-CF44-AF40-CF17004289A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229" r="1"/>
          <a:stretch/>
        </p:blipFill>
        <p:spPr>
          <a:xfrm>
            <a:off x="562709" y="1146448"/>
            <a:ext cx="5645360" cy="44024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5409842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DA9DD50A-359A-054B-949F-3424400E76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5493" y="107218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2: Luminal A Complete Pathological Response (CPR) ET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="" xmlns:a16="http://schemas.microsoft.com/office/drawing/2014/main" id="{BDE6093A-AEE0-8C41-9987-DE727069FB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5493" y="1135919"/>
            <a:ext cx="5907427" cy="45302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73315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A726AA8-5D2F-7246-8189-44E2BECA29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28600" y="0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3: </a:t>
            </a:r>
            <a:r>
              <a:rPr lang="en-US" sz="1400" b="1" dirty="0"/>
              <a:t>Luminal B </a:t>
            </a:r>
            <a:r>
              <a:rPr lang="en-US" sz="1400" b="1" dirty="0" smtClean="0"/>
              <a:t>5yrs </a:t>
            </a:r>
            <a:r>
              <a:rPr lang="en-US" sz="1400" b="1" dirty="0"/>
              <a:t>RFS -  Chemotherapy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07984FE6-EED7-4E47-9CC0-4CC8B97EF78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90"/>
          <a:stretch/>
        </p:blipFill>
        <p:spPr>
          <a:xfrm>
            <a:off x="312615" y="1015941"/>
            <a:ext cx="6096000" cy="470132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44822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9310407-0EA7-AF49-9F42-3CBE9D0561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8354" y="143119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</a:t>
            </a:r>
            <a:r>
              <a:rPr lang="en-US" sz="1400" b="1" dirty="0" smtClean="0"/>
              <a:t>4: </a:t>
            </a:r>
            <a:r>
              <a:rPr lang="en-US" sz="1400" b="1" dirty="0"/>
              <a:t>Luminal B CPR Chemotherapy </a:t>
            </a:r>
          </a:p>
        </p:txBody>
      </p:sp>
      <p:pic>
        <p:nvPicPr>
          <p:cNvPr id="5" name="Content Placeholder 4">
            <a:extLst>
              <a:ext uri="{FF2B5EF4-FFF2-40B4-BE49-F238E27FC236}">
                <a16:creationId xmlns="" xmlns:a16="http://schemas.microsoft.com/office/drawing/2014/main" id="{F67351C6-F6F3-814F-B171-17A02D7172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466888" y="1458302"/>
            <a:ext cx="5629111" cy="4351338"/>
          </a:xfrm>
        </p:spPr>
      </p:pic>
    </p:spTree>
    <p:extLst>
      <p:ext uri="{BB962C8B-B14F-4D97-AF65-F5344CB8AC3E}">
        <p14:creationId xmlns:p14="http://schemas.microsoft.com/office/powerpoint/2010/main" val="11546976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66A2BCD-22BC-834E-A19B-16CF9DDD97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44230" y="255709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5: Her2+ve only </a:t>
            </a:r>
            <a:r>
              <a:rPr lang="en-US" sz="1400" b="1" dirty="0" smtClean="0"/>
              <a:t>5yrs </a:t>
            </a:r>
            <a:r>
              <a:rPr lang="en-US" sz="1400" b="1" dirty="0"/>
              <a:t>RFS  - Chemotherapy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86268D2C-9377-48F8-A909-C7600B9F0BF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36"/>
          <a:stretch/>
        </p:blipFill>
        <p:spPr>
          <a:xfrm>
            <a:off x="398584" y="1393703"/>
            <a:ext cx="5721093" cy="48429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23354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FBD9A0A-38D7-F04D-930A-539C2F25A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5681" y="130664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6: Her2+ve only CPR Chemotherapy 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46B3E669-DDFC-4159-9766-F9DB6F18DCF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41"/>
          <a:stretch/>
        </p:blipFill>
        <p:spPr>
          <a:xfrm>
            <a:off x="304800" y="1130002"/>
            <a:ext cx="5720862" cy="48723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0565738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98B0D08-633D-41A4-A150-37F39C80F1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97338" y="201002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7: </a:t>
            </a:r>
            <a:r>
              <a:rPr lang="en-US" sz="1400" b="1" dirty="0" smtClean="0"/>
              <a:t>HER2+ve </a:t>
            </a:r>
            <a:r>
              <a:rPr lang="en-US" sz="1400" b="1" dirty="0"/>
              <a:t>only </a:t>
            </a:r>
            <a:r>
              <a:rPr lang="en-US" sz="1400" b="1" dirty="0" smtClean="0"/>
              <a:t>5yrs - RFS anti-HER2 </a:t>
            </a:r>
            <a:r>
              <a:rPr lang="en-US" sz="1400" b="1" dirty="0"/>
              <a:t>only</a:t>
            </a:r>
            <a:endParaRPr lang="en-GB" sz="1400" b="1" dirty="0"/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B5949CD2-1FBB-41BA-9A0F-531782AE018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39"/>
          <a:stretch/>
        </p:blipFill>
        <p:spPr>
          <a:xfrm>
            <a:off x="312615" y="1217966"/>
            <a:ext cx="5436634" cy="4573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617138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680C67B-ABA8-4561-A947-764EA449BDD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5154" y="224448"/>
            <a:ext cx="10515600" cy="1325563"/>
          </a:xfrm>
        </p:spPr>
        <p:txBody>
          <a:bodyPr>
            <a:normAutofit/>
          </a:bodyPr>
          <a:lstStyle/>
          <a:p>
            <a:r>
              <a:rPr lang="en-US" sz="1400" b="1" dirty="0"/>
              <a:t>Supplementary Figure 8: </a:t>
            </a:r>
            <a:r>
              <a:rPr lang="en-US" sz="1400" b="1" dirty="0" smtClean="0"/>
              <a:t>HER2+ve </a:t>
            </a:r>
            <a:r>
              <a:rPr lang="en-US" sz="1400" b="1" dirty="0"/>
              <a:t>only </a:t>
            </a:r>
            <a:r>
              <a:rPr lang="en-US" sz="1400" b="1" dirty="0" smtClean="0"/>
              <a:t>CPR -  anti-HER2 </a:t>
            </a:r>
            <a:r>
              <a:rPr lang="en-US" sz="1400" b="1" dirty="0"/>
              <a:t>only</a:t>
            </a:r>
            <a:endParaRPr lang="en-GB" sz="1400" b="1" dirty="0"/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529A0AD3-43C7-4B67-859A-287E9A43CF0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4514" y="1331959"/>
            <a:ext cx="5609126" cy="454521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24673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188</Words>
  <Application>Microsoft Office PowerPoint</Application>
  <PresentationFormat>Widescreen</PresentationFormat>
  <Paragraphs>12</Paragraphs>
  <Slides>1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Supplementary Figure 1: Luminal A 5yrs Relapse Free Survival (RFS) - Endocrine treatment (ET)</vt:lpstr>
      <vt:lpstr>Supplementary Figure 2: Luminal A Complete Pathological Response (CPR) ET</vt:lpstr>
      <vt:lpstr>Supplementary Figure 3: Luminal B 5yrs RFS -  Chemotherapy </vt:lpstr>
      <vt:lpstr>Supplementary Figure 4: Luminal B CPR Chemotherapy </vt:lpstr>
      <vt:lpstr>Supplementary Figure 5: Her2+ve only 5yrs RFS  - Chemotherapy </vt:lpstr>
      <vt:lpstr>Supplementary Figure 6: Her2+ve only CPR Chemotherapy </vt:lpstr>
      <vt:lpstr>Supplementary Figure 7: HER2+ve only 5yrs - RFS anti-HER2 only</vt:lpstr>
      <vt:lpstr>Supplementary Figure 8: HER2+ve only CPR -  anti-HER2 only</vt:lpstr>
      <vt:lpstr>Supplementary Figure 9: TNBC 5yrs RFS -  Chemotherapy </vt:lpstr>
      <vt:lpstr>Supplementary Figure 10: TNBC - CPR Chemotherapy  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uminal A 5yr RFS Endo treatment</dc:title>
  <dc:creator>Mitali Das</dc:creator>
  <cp:lastModifiedBy>Giannoudis, Athina</cp:lastModifiedBy>
  <cp:revision>12</cp:revision>
  <dcterms:created xsi:type="dcterms:W3CDTF">2021-08-24T12:06:14Z</dcterms:created>
  <dcterms:modified xsi:type="dcterms:W3CDTF">2022-07-15T13:07:37Z</dcterms:modified>
</cp:coreProperties>
</file>